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9601200" cy="12801600" type="A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41" d="100"/>
          <a:sy n="41" d="100"/>
        </p:scale>
        <p:origin x="-2166" y="-7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548670531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Shape 96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Shape 97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빈 화면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 b="0" i="0" u="none" strike="noStrike" cap="none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제목 및 세로 텍스트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576368" y="2890734"/>
            <a:ext cx="8448464" cy="86410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>
  <p:cSld name="세로 제목 및 텍스트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-1250157" y="7155340"/>
            <a:ext cx="14561820" cy="16202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4570570" y="5615147"/>
            <a:ext cx="14561820" cy="4700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제목 슬라이드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ctrTitle"/>
          </p:nvPr>
        </p:nvSpPr>
        <p:spPr>
          <a:xfrm>
            <a:off x="720090" y="3976796"/>
            <a:ext cx="8161020" cy="27440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ctr" rtl="0">
              <a:spcBef>
                <a:spcPts val="900"/>
              </a:spcBef>
              <a:spcAft>
                <a:spcPts val="0"/>
              </a:spcAft>
              <a:buClr>
                <a:srgbClr val="888888"/>
              </a:buClr>
              <a:buSzPts val="4500"/>
              <a:buFont typeface="Arial"/>
              <a:buNone/>
              <a:defRPr sz="45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spcBef>
                <a:spcPts val="780"/>
              </a:spcBef>
              <a:spcAft>
                <a:spcPts val="0"/>
              </a:spcAft>
              <a:buClr>
                <a:srgbClr val="888888"/>
              </a:buClr>
              <a:buSzPts val="3900"/>
              <a:buFont typeface="Arial"/>
              <a:buNone/>
              <a:defRPr sz="3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spcBef>
                <a:spcPts val="680"/>
              </a:spcBef>
              <a:spcAft>
                <a:spcPts val="0"/>
              </a:spcAft>
              <a:buClr>
                <a:srgbClr val="888888"/>
              </a:buClr>
              <a:buSzPts val="3400"/>
              <a:buFont typeface="Arial"/>
              <a:buNone/>
              <a:defRPr sz="34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제목 및 내용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구역 머리글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600"/>
              <a:buFont typeface="Arial"/>
              <a:buNone/>
              <a:defRPr sz="5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500"/>
              <a:buFont typeface="Arial"/>
              <a:buNone/>
              <a:defRPr sz="25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440"/>
              </a:spcBef>
              <a:spcAft>
                <a:spcPts val="0"/>
              </a:spcAft>
              <a:buClr>
                <a:srgbClr val="888888"/>
              </a:buClr>
              <a:buSzPts val="2200"/>
              <a:buFont typeface="Arial"/>
              <a:buNone/>
              <a:defRPr sz="2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콘텐츠 2개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60046" y="3982721"/>
            <a:ext cx="3160395" cy="11263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•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–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–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»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680461" y="3982721"/>
            <a:ext cx="3160395" cy="11263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•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–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–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»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비교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None/>
              <a:defRPr sz="25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480061" y="4059766"/>
            <a:ext cx="4242197" cy="737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–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»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4877278" y="2865544"/>
            <a:ext cx="4243863" cy="1194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None/>
              <a:defRPr sz="25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4877278" y="4059766"/>
            <a:ext cx="4243863" cy="737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–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»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제목만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>
  <p:cSld name="캡션 있는 콘텐츠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480061" y="509694"/>
            <a:ext cx="3158729" cy="2169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3753803" y="509695"/>
            <a:ext cx="5367338" cy="109258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480061" y="2678855"/>
            <a:ext cx="3158729" cy="8756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>
  <p:cSld name="캡션 있는 그림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881902" y="1143846"/>
            <a:ext cx="5760720" cy="768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None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None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881902" y="10019032"/>
            <a:ext cx="5760720" cy="15024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 b="0" i="0" u="none" strike="noStrike" cap="none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Shape 9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40601" y="2368352"/>
            <a:ext cx="3960000" cy="30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0" name="Shape 10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846384" y="2368352"/>
            <a:ext cx="3960000" cy="30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Shape 101"/>
          <p:cNvSpPr/>
          <p:nvPr/>
        </p:nvSpPr>
        <p:spPr>
          <a:xfrm>
            <a:off x="840601" y="5632519"/>
            <a:ext cx="796578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GB" sz="1800" b="1" dirty="0">
                <a:solidFill>
                  <a:schemeClr val="dk1"/>
                </a:solidFill>
              </a:rPr>
              <a:t>Supplementary Video 2: Penetration of HPA3P into HCT116 p53</a:t>
            </a:r>
            <a:r>
              <a:rPr lang="en-GB" sz="1800" b="1" baseline="30000" dirty="0">
                <a:solidFill>
                  <a:schemeClr val="dk1"/>
                </a:solidFill>
              </a:rPr>
              <a:t>+/+</a:t>
            </a:r>
            <a:r>
              <a:rPr lang="en-GB" sz="1800" b="1" dirty="0">
                <a:solidFill>
                  <a:schemeClr val="dk1"/>
                </a:solidFill>
              </a:rPr>
              <a:t> cells. </a:t>
            </a:r>
            <a:r>
              <a:rPr lang="en-GB" sz="1800" dirty="0">
                <a:solidFill>
                  <a:schemeClr val="dk1"/>
                </a:solidFill>
              </a:rPr>
              <a:t>HCT116 p53</a:t>
            </a:r>
            <a:r>
              <a:rPr lang="en-GB" sz="1800" baseline="30000" dirty="0">
                <a:solidFill>
                  <a:schemeClr val="dk1"/>
                </a:solidFill>
              </a:rPr>
              <a:t>+/+</a:t>
            </a:r>
            <a:r>
              <a:rPr lang="en-GB" sz="1800" dirty="0">
                <a:solidFill>
                  <a:schemeClr val="dk1"/>
                </a:solidFill>
              </a:rPr>
              <a:t> cells were treated with 30 </a:t>
            </a:r>
            <a:r>
              <a:rPr lang="en-GB" sz="1800" dirty="0" err="1">
                <a:solidFill>
                  <a:schemeClr val="dk1"/>
                </a:solidFill>
              </a:rPr>
              <a:t>μM</a:t>
            </a:r>
            <a:r>
              <a:rPr lang="en-GB" sz="1800" dirty="0">
                <a:solidFill>
                  <a:schemeClr val="dk1"/>
                </a:solidFill>
              </a:rPr>
              <a:t>/ml </a:t>
            </a:r>
            <a:r>
              <a:rPr lang="en-GB" sz="1800" dirty="0" err="1">
                <a:solidFill>
                  <a:schemeClr val="dk1"/>
                </a:solidFill>
              </a:rPr>
              <a:t>rhodamine</a:t>
            </a:r>
            <a:r>
              <a:rPr lang="en-GB" sz="1800" dirty="0">
                <a:solidFill>
                  <a:schemeClr val="dk1"/>
                </a:solidFill>
              </a:rPr>
              <a:t>-labelled HPA3P, and then fluorescence was measured for 20 min using an </a:t>
            </a:r>
            <a:r>
              <a:rPr lang="en-GB" sz="1800" dirty="0" err="1">
                <a:solidFill>
                  <a:schemeClr val="dk1"/>
                </a:solidFill>
              </a:rPr>
              <a:t>IncuCyte</a:t>
            </a:r>
            <a:r>
              <a:rPr lang="en-GB" sz="1800" dirty="0">
                <a:solidFill>
                  <a:schemeClr val="dk1"/>
                </a:solidFill>
              </a:rPr>
              <a:t> ZOOM imaging system.</a:t>
            </a:r>
            <a:endParaRPr sz="18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A3 Paper (297x420 mm)</PresentationFormat>
  <Paragraphs>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2</cp:revision>
  <dcterms:modified xsi:type="dcterms:W3CDTF">2018-01-18T11:36:40Z</dcterms:modified>
</cp:coreProperties>
</file>